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492CE-2826-41FC-9D2F-986CF742ED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0F705-08D4-47EF-9410-D62C122CCE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081EFE-864B-449B-8199-DACEE58441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C7DED6-4F35-49CB-8A55-376D9B915B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ABBB4D-BD0C-46B5-B040-9407E3AB34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A0AAD-D518-4497-A63E-E20ED107ED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8B4655-CA0B-4A7B-8D21-5EAE2F0036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462E5D-94A9-450F-8EA0-DD63FC93F5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38B60-B028-47DF-96AF-C0B6240D02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5C0A82-0A84-4C57-ADD0-179C954B73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BC470-472C-4D9D-866F-9D49B836EC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E1A49F-38D4-4975-9006-5FB3901823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B9D313-C8B7-4A99-819D-967A71F217A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0"/>
          <p:cNvGrpSpPr/>
          <p:nvPr/>
        </p:nvGrpSpPr>
        <p:grpSpPr>
          <a:xfrm>
            <a:off x="76320" y="609480"/>
            <a:ext cx="6626160" cy="4756680"/>
            <a:chOff x="76320" y="609480"/>
            <a:chExt cx="6626160" cy="4756680"/>
          </a:xfrm>
        </p:grpSpPr>
        <p:grpSp>
          <p:nvGrpSpPr>
            <p:cNvPr id="42" name="Group 15"/>
            <p:cNvGrpSpPr/>
            <p:nvPr/>
          </p:nvGrpSpPr>
          <p:grpSpPr>
            <a:xfrm>
              <a:off x="533520" y="609480"/>
              <a:ext cx="6168960" cy="4756680"/>
              <a:chOff x="533520" y="609480"/>
              <a:chExt cx="6168960" cy="4756680"/>
            </a:xfrm>
          </p:grpSpPr>
          <p:grpSp>
            <p:nvGrpSpPr>
              <p:cNvPr id="43" name="Gruppo 5"/>
              <p:cNvGrpSpPr/>
              <p:nvPr/>
            </p:nvGrpSpPr>
            <p:grpSpPr>
              <a:xfrm>
                <a:off x="533520" y="609480"/>
                <a:ext cx="2972160" cy="1964520"/>
                <a:chOff x="533520" y="609480"/>
                <a:chExt cx="2972160" cy="1964520"/>
              </a:xfrm>
            </p:grpSpPr>
            <p:pic>
              <p:nvPicPr>
                <p:cNvPr id="44" name="Picture 2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533520" y="609480"/>
                  <a:ext cx="2972160" cy="19645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5" name="Rettangolo 1"/>
                <p:cNvSpPr/>
                <p:nvPr/>
              </p:nvSpPr>
              <p:spPr>
                <a:xfrm>
                  <a:off x="2005200" y="968040"/>
                  <a:ext cx="442800" cy="2826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46" name="Group 5"/>
              <p:cNvGrpSpPr/>
              <p:nvPr/>
            </p:nvGrpSpPr>
            <p:grpSpPr>
              <a:xfrm>
                <a:off x="3882600" y="609480"/>
                <a:ext cx="2819880" cy="1964520"/>
                <a:chOff x="3882600" y="609480"/>
                <a:chExt cx="2819880" cy="1964520"/>
              </a:xfrm>
            </p:grpSpPr>
            <p:pic>
              <p:nvPicPr>
                <p:cNvPr id="47" name="Picture 2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3882600" y="609480"/>
                  <a:ext cx="2819880" cy="19645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8" name="Rectangle 4"/>
                <p:cNvSpPr/>
                <p:nvPr/>
              </p:nvSpPr>
              <p:spPr>
                <a:xfrm>
                  <a:off x="5292720" y="968040"/>
                  <a:ext cx="269640" cy="2826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49" name="Group 7"/>
              <p:cNvGrpSpPr/>
              <p:nvPr/>
            </p:nvGrpSpPr>
            <p:grpSpPr>
              <a:xfrm>
                <a:off x="533520" y="2819160"/>
                <a:ext cx="2957760" cy="2028600"/>
                <a:chOff x="533520" y="2819160"/>
                <a:chExt cx="2957760" cy="2028600"/>
              </a:xfrm>
            </p:grpSpPr>
            <p:pic>
              <p:nvPicPr>
                <p:cNvPr id="50" name="Picture 3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533520" y="2819160"/>
                  <a:ext cx="2957760" cy="2028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1" name="Rectangle 6"/>
                <p:cNvSpPr/>
                <p:nvPr/>
              </p:nvSpPr>
              <p:spPr>
                <a:xfrm>
                  <a:off x="2013120" y="3200400"/>
                  <a:ext cx="382320" cy="3045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2" name="Group 9"/>
              <p:cNvGrpSpPr/>
              <p:nvPr/>
            </p:nvGrpSpPr>
            <p:grpSpPr>
              <a:xfrm>
                <a:off x="3925800" y="2819160"/>
                <a:ext cx="2733840" cy="2028600"/>
                <a:chOff x="3925800" y="2819160"/>
                <a:chExt cx="2733840" cy="2028600"/>
              </a:xfrm>
            </p:grpSpPr>
            <p:pic>
              <p:nvPicPr>
                <p:cNvPr id="53" name="Picture 4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3925800" y="2819160"/>
                  <a:ext cx="2733840" cy="2028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4" name="Rectangle 8"/>
                <p:cNvSpPr/>
                <p:nvPr/>
              </p:nvSpPr>
              <p:spPr>
                <a:xfrm>
                  <a:off x="5293080" y="3200400"/>
                  <a:ext cx="269640" cy="3045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55" name="TextBox 10"/>
              <p:cNvSpPr/>
              <p:nvPr/>
            </p:nvSpPr>
            <p:spPr>
              <a:xfrm>
                <a:off x="2004480" y="914040"/>
                <a:ext cx="4244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2%                                                  30%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TextBox 11"/>
              <p:cNvSpPr/>
              <p:nvPr/>
            </p:nvSpPr>
            <p:spPr>
              <a:xfrm>
                <a:off x="533520" y="5028840"/>
                <a:ext cx="19141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FDA-SE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57" name="Straight Arrow Connector 13"/>
              <p:cNvCxnSpPr/>
              <p:nvPr/>
            </p:nvCxnSpPr>
            <p:spPr>
              <a:xfrm>
                <a:off x="1828800" y="5197320"/>
                <a:ext cx="4725000" cy="1080"/>
              </a:xfrm>
              <a:prstGeom prst="straightConnector1">
                <a:avLst/>
              </a:prstGeom>
              <a:ln w="381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58" name="TextBox 14"/>
              <p:cNvSpPr/>
              <p:nvPr/>
            </p:nvSpPr>
            <p:spPr>
              <a:xfrm>
                <a:off x="1828800" y="3200040"/>
                <a:ext cx="442008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%                                                     15%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17%)                                                 (50%)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9" name="TextBox 16"/>
            <p:cNvSpPr/>
            <p:nvPr/>
          </p:nvSpPr>
          <p:spPr>
            <a:xfrm>
              <a:off x="76320" y="609480"/>
              <a:ext cx="380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17"/>
            <p:cNvSpPr/>
            <p:nvPr/>
          </p:nvSpPr>
          <p:spPr>
            <a:xfrm>
              <a:off x="3505680" y="609480"/>
              <a:ext cx="376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18"/>
            <p:cNvSpPr/>
            <p:nvPr/>
          </p:nvSpPr>
          <p:spPr>
            <a:xfrm>
              <a:off x="76320" y="2819160"/>
              <a:ext cx="380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19"/>
            <p:cNvSpPr/>
            <p:nvPr/>
          </p:nvSpPr>
          <p:spPr>
            <a:xfrm>
              <a:off x="3505680" y="2819160"/>
              <a:ext cx="376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3" name="TextBox 21"/>
          <p:cNvSpPr/>
          <p:nvPr/>
        </p:nvSpPr>
        <p:spPr>
          <a:xfrm>
            <a:off x="304920" y="5486400"/>
            <a:ext cx="81151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Figure 2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Experiment of suppression activity  by  CD4+CD25high Treg  lymphocytes. The histograms refer to the proliferation activity of a healthy control responder  PBMC stimulated with an anti-CD3 mAb cultured without CD4+CD25high Treg  (Panel B), with CD4+CD25high Treg  sorted  by  our patient PBMC (Panel C), or with CD4+CD25high Treg  sorted  by  our patient‘s sibling PBMC (Panel D). Panel A shows  the level of proliferation of unstimulated responder  PBMC (healthy control) . The percentages of proliferating cells are shown in all the  panels while the percentages of suppression activity are indicated between parentheses in the  Panel C and  D, respectivel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CasellaDiTesto 24"/>
          <p:cNvSpPr/>
          <p:nvPr/>
        </p:nvSpPr>
        <p:spPr>
          <a:xfrm>
            <a:off x="6781680" y="1143000"/>
            <a:ext cx="2210040" cy="350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  </a:t>
            </a:r>
            <a:r>
              <a:rPr b="0" lang="it-IT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sponder not stimulated (Healthy control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  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  <a:ea typeface="Arial"/>
              </a:rPr>
              <a:t>Responder  OKT3 pulse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 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  <a:ea typeface="Arial"/>
              </a:rPr>
              <a:t>Responder OKT3 pulsed +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Calibri"/>
                <a:ea typeface="Arial"/>
              </a:rPr>
              <a:t>Sorted CD4+ Treg (Patient)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. 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  <a:ea typeface="Arial"/>
              </a:rPr>
              <a:t>Responder OKT3 pulsed +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000000"/>
                </a:solidFill>
                <a:latin typeface="Calibri"/>
                <a:ea typeface="Arial"/>
              </a:rPr>
              <a:t>Sorted CD4+ Treg (Sibling-HSCT donor)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2-13T01:49:33Z</dcterms:created>
  <dc:creator>Admin</dc:creator>
  <dc:description/>
  <dc:language>en-US</dc:language>
  <cp:lastModifiedBy>Edoardo La Porta</cp:lastModifiedBy>
  <dcterms:modified xsi:type="dcterms:W3CDTF">2022-02-22T14:36:25Z</dcterms:modified>
  <cp:revision>16</cp:revision>
  <dc:subject/>
  <dc:title>PowerPoint Presentation</dc:title>
</cp:coreProperties>
</file>